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6A6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72" d="100"/>
          <a:sy n="72" d="100"/>
        </p:scale>
        <p:origin x="45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&#12488;&#12507;&#12464;&#12522;&#12501;&#12525;&#12472;&#12531;\&#12488;&#12507;&#12464;&#12522;&#12501;&#12525;&#12472;&#12531;&#35542;&#25991;&#21270;\&#37329;&#27810;&#22823;&#23398;&#31681;&#20426;&#25104;Dr&#35542;&#25991;\SGLT2_ALT\211228\&#35299;&#26512;&#32080;&#26524;\211215Result_Fig_ALL_&#20316;&#22259;&#29992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&#12488;&#12507;&#12464;&#12522;&#12501;&#12525;&#12472;&#12531;\&#12488;&#12507;&#12464;&#12522;&#12501;&#12525;&#12472;&#12531;&#35542;&#25991;&#21270;\&#37329;&#27810;&#22823;&#23398;&#31681;&#20426;&#25104;Dr&#35542;&#25991;\SGLT2_ALT\211228\&#35299;&#26512;&#32080;&#26524;\211215Result_Fig_ALL_&#20316;&#22259;&#2999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SMeans!$F$16:$F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52209531535035403</c:v>
                  </c:pt>
                  <c:pt idx="2">
                    <c:v>0.52836816833962497</c:v>
                  </c:pt>
                </c:numCache>
              </c:numRef>
            </c:plus>
            <c:minus>
              <c:numRef>
                <c:f>LSMeans!$F$16:$F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52209531535035403</c:v>
                  </c:pt>
                  <c:pt idx="2">
                    <c:v>0.528368168339624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LSMeans!$D$16:$D$18</c:f>
              <c:numCache>
                <c:formatCode>General</c:formatCode>
                <c:ptCount val="3"/>
                <c:pt idx="0">
                  <c:v>0</c:v>
                </c:pt>
                <c:pt idx="1">
                  <c:v>12</c:v>
                </c:pt>
                <c:pt idx="2">
                  <c:v>24</c:v>
                </c:pt>
              </c:numCache>
            </c:numRef>
          </c:xVal>
          <c:yVal>
            <c:numRef>
              <c:f>LSMeans!$E$16:$E$18</c:f>
              <c:numCache>
                <c:formatCode>General</c:formatCode>
                <c:ptCount val="3"/>
                <c:pt idx="0">
                  <c:v>0</c:v>
                </c:pt>
                <c:pt idx="1">
                  <c:v>-4.0437635285697402</c:v>
                </c:pt>
                <c:pt idx="2">
                  <c:v>-3.22704674518905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667-43D5-9D00-83F97179BB1E}"/>
            </c:ext>
          </c:extLst>
        </c:ser>
        <c:ser>
          <c:idx val="1"/>
          <c:order val="1"/>
          <c:spPr>
            <a:ln w="19050" cap="rnd">
              <a:solidFill>
                <a:sysClr val="window" lastClr="FFFFFF">
                  <a:lumMod val="65000"/>
                </a:sys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ysClr val="window" lastClr="FFFFFF">
                  <a:lumMod val="65000"/>
                </a:sysClr>
              </a:solidFill>
              <a:ln w="9525">
                <a:solidFill>
                  <a:sysClr val="window" lastClr="FFFFFF">
                    <a:lumMod val="65000"/>
                  </a:sys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SMeans!$F$19:$F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2570415699422699</c:v>
                  </c:pt>
                  <c:pt idx="2">
                    <c:v>2.3136646133190801</c:v>
                  </c:pt>
                </c:numCache>
              </c:numRef>
            </c:plus>
            <c:minus>
              <c:numRef>
                <c:f>LSMeans!$F$19:$F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2570415699422699</c:v>
                  </c:pt>
                  <c:pt idx="2">
                    <c:v>2.3136646133190801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A6A6A6"/>
                </a:solidFill>
                <a:round/>
              </a:ln>
              <a:effectLst/>
            </c:spPr>
          </c:errBars>
          <c:xVal>
            <c:numRef>
              <c:f>LSMeans!$D$19:$D$21</c:f>
              <c:numCache>
                <c:formatCode>General</c:formatCode>
                <c:ptCount val="3"/>
                <c:pt idx="0">
                  <c:v>0.5</c:v>
                </c:pt>
                <c:pt idx="1">
                  <c:v>12.5</c:v>
                </c:pt>
                <c:pt idx="2">
                  <c:v>24.5</c:v>
                </c:pt>
              </c:numCache>
            </c:numRef>
          </c:xVal>
          <c:yVal>
            <c:numRef>
              <c:f>LSMeans!$E$19:$E$21</c:f>
              <c:numCache>
                <c:formatCode>General</c:formatCode>
                <c:ptCount val="3"/>
                <c:pt idx="0">
                  <c:v>0</c:v>
                </c:pt>
                <c:pt idx="1">
                  <c:v>0.31240963389307103</c:v>
                </c:pt>
                <c:pt idx="2">
                  <c:v>0.741483129890590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667-43D5-9D00-83F97179BB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5499136"/>
        <c:axId val="515500448"/>
      </c:scatterChart>
      <c:valAx>
        <c:axId val="515499136"/>
        <c:scaling>
          <c:orientation val="minMax"/>
          <c:max val="26"/>
          <c:min val="-4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15500448"/>
        <c:crosses val="autoZero"/>
        <c:crossBetween val="midCat"/>
        <c:majorUnit val="4"/>
      </c:valAx>
      <c:valAx>
        <c:axId val="515500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15499136"/>
        <c:crossesAt val="-4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SMeans!$F$53:$F$5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2885107292193898</c:v>
                  </c:pt>
                  <c:pt idx="2">
                    <c:v>3.3887305311498999</c:v>
                  </c:pt>
                </c:numCache>
              </c:numRef>
            </c:plus>
            <c:minus>
              <c:numRef>
                <c:f>LSMeans!$F$53:$F$5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2885107292193898</c:v>
                  </c:pt>
                  <c:pt idx="2">
                    <c:v>3.3887305311498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LSMeans!$D$16:$D$18</c:f>
              <c:numCache>
                <c:formatCode>General</c:formatCode>
                <c:ptCount val="3"/>
                <c:pt idx="0">
                  <c:v>0</c:v>
                </c:pt>
                <c:pt idx="1">
                  <c:v>12</c:v>
                </c:pt>
                <c:pt idx="2">
                  <c:v>24</c:v>
                </c:pt>
              </c:numCache>
            </c:numRef>
          </c:xVal>
          <c:yVal>
            <c:numRef>
              <c:f>LSMeans!$E$50:$E$52</c:f>
              <c:numCache>
                <c:formatCode>General</c:formatCode>
                <c:ptCount val="3"/>
                <c:pt idx="0">
                  <c:v>0</c:v>
                </c:pt>
                <c:pt idx="1">
                  <c:v>4.0208882784973001</c:v>
                </c:pt>
                <c:pt idx="2">
                  <c:v>3.58966559915169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BD-4323-AC3C-52A36CBA4E9E}"/>
            </c:ext>
          </c:extLst>
        </c:ser>
        <c:ser>
          <c:idx val="1"/>
          <c:order val="1"/>
          <c:spPr>
            <a:ln w="19050" cap="rnd">
              <a:solidFill>
                <a:srgbClr val="A6A6A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ysClr val="window" lastClr="FFFFFF">
                  <a:lumMod val="65000"/>
                </a:sysClr>
              </a:solidFill>
              <a:ln w="9525">
                <a:solidFill>
                  <a:srgbClr val="A6A6A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SMeans!$F$53:$F$5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2885107292193898</c:v>
                  </c:pt>
                  <c:pt idx="2">
                    <c:v>3.3887305311498999</c:v>
                  </c:pt>
                </c:numCache>
              </c:numRef>
            </c:plus>
            <c:minus>
              <c:numRef>
                <c:f>LSMeans!$F$53:$F$5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2885107292193898</c:v>
                  </c:pt>
                  <c:pt idx="2">
                    <c:v>3.3887305311498999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A6A6A6"/>
                </a:solidFill>
                <a:round/>
              </a:ln>
              <a:effectLst/>
            </c:spPr>
          </c:errBars>
          <c:xVal>
            <c:numRef>
              <c:f>LSMeans!$D$19:$D$21</c:f>
              <c:numCache>
                <c:formatCode>General</c:formatCode>
                <c:ptCount val="3"/>
                <c:pt idx="0">
                  <c:v>0.5</c:v>
                </c:pt>
                <c:pt idx="1">
                  <c:v>12.5</c:v>
                </c:pt>
                <c:pt idx="2">
                  <c:v>24.5</c:v>
                </c:pt>
              </c:numCache>
            </c:numRef>
          </c:xVal>
          <c:yVal>
            <c:numRef>
              <c:f>LSMeans!$E$53:$E$55</c:f>
              <c:numCache>
                <c:formatCode>General</c:formatCode>
                <c:ptCount val="3"/>
                <c:pt idx="0">
                  <c:v>0</c:v>
                </c:pt>
                <c:pt idx="1">
                  <c:v>-2.8072778402042502</c:v>
                </c:pt>
                <c:pt idx="2">
                  <c:v>6.61095263953880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6BD-4323-AC3C-52A36CBA4E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5499136"/>
        <c:axId val="515500448"/>
      </c:scatterChart>
      <c:valAx>
        <c:axId val="515499136"/>
        <c:scaling>
          <c:orientation val="minMax"/>
          <c:max val="26"/>
          <c:min val="-4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15500448"/>
        <c:crosses val="autoZero"/>
        <c:crossBetween val="midCat"/>
        <c:majorUnit val="4"/>
      </c:valAx>
      <c:valAx>
        <c:axId val="515500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15499136"/>
        <c:crossesAt val="-4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714355-D67B-4A32-91F1-2872E5518171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26735A-81A6-48CB-86C9-A2C73CFD0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1043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103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391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1131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626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162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493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15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121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600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227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3478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AE185-CB09-408F-93BA-7F0DF67C1CC7}" type="datetimeFigureOut">
              <a:rPr kumimoji="1" lang="ja-JP" altLang="en-US" smtClean="0"/>
              <a:t>2023/3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221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D89680C3-9722-4FA9-B936-0DD81AE37C62}"/>
              </a:ext>
            </a:extLst>
          </p:cNvPr>
          <p:cNvSpPr/>
          <p:nvPr/>
        </p:nvSpPr>
        <p:spPr>
          <a:xfrm rot="16200000">
            <a:off x="-789701" y="1765318"/>
            <a:ext cx="24125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change in BAP (%)</a:t>
            </a:r>
            <a:endParaRPr lang="ja-JP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190145D-6387-4EDF-900D-832378CC839E}"/>
              </a:ext>
            </a:extLst>
          </p:cNvPr>
          <p:cNvSpPr/>
          <p:nvPr/>
        </p:nvSpPr>
        <p:spPr>
          <a:xfrm rot="16200000">
            <a:off x="3191979" y="1765318"/>
            <a:ext cx="23984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change in </a:t>
            </a:r>
            <a:r>
              <a:rPr lang="en-US" altLang="ja-JP" sz="14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x</a:t>
            </a:r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ja-JP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61D47B84-092F-4F76-9C76-7ED521744ECC}"/>
              </a:ext>
            </a:extLst>
          </p:cNvPr>
          <p:cNvSpPr/>
          <p:nvPr/>
        </p:nvSpPr>
        <p:spPr>
          <a:xfrm>
            <a:off x="3591446" y="720000"/>
            <a:ext cx="6719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weeks)</a:t>
            </a:r>
            <a:endParaRPr lang="ja-JP" altLang="en-US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2885852-753B-47D3-8458-F89B1E66D105}"/>
              </a:ext>
            </a:extLst>
          </p:cNvPr>
          <p:cNvSpPr/>
          <p:nvPr/>
        </p:nvSpPr>
        <p:spPr>
          <a:xfrm>
            <a:off x="7554735" y="720000"/>
            <a:ext cx="6719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weeks)</a:t>
            </a:r>
            <a:endParaRPr lang="ja-JP" altLang="en-US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724877A-3C89-4B5B-B0B2-B5843BAF16EC}"/>
              </a:ext>
            </a:extLst>
          </p:cNvPr>
          <p:cNvSpPr txBox="1"/>
          <p:nvPr/>
        </p:nvSpPr>
        <p:spPr>
          <a:xfrm>
            <a:off x="921947" y="2924514"/>
            <a:ext cx="2891803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852, time-treatment interactio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FE72EAD-E05C-4495-ADDD-E6871118E7DB}"/>
              </a:ext>
            </a:extLst>
          </p:cNvPr>
          <p:cNvSpPr txBox="1"/>
          <p:nvPr/>
        </p:nvSpPr>
        <p:spPr>
          <a:xfrm>
            <a:off x="5130150" y="2924514"/>
            <a:ext cx="2891803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, time-treatment interactio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3BF967D-92C6-4697-9AE1-78F23C214B5A}"/>
              </a:ext>
            </a:extLst>
          </p:cNvPr>
          <p:cNvSpPr txBox="1"/>
          <p:nvPr/>
        </p:nvSpPr>
        <p:spPr>
          <a:xfrm>
            <a:off x="1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-course percentage changes in levels of variables</a:t>
            </a:r>
            <a:endParaRPr lang="ja-JP" altLang="ja-JP" sz="2000" u="sng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2D16DD6E-7083-4967-8D6B-2C89E1D106F8}"/>
              </a:ext>
            </a:extLst>
          </p:cNvPr>
          <p:cNvSpPr/>
          <p:nvPr/>
        </p:nvSpPr>
        <p:spPr>
          <a:xfrm>
            <a:off x="102743" y="504000"/>
            <a:ext cx="6281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4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32743E36-4F71-40D8-AF82-955BF2ADAD47}"/>
              </a:ext>
            </a:extLst>
          </p:cNvPr>
          <p:cNvSpPr/>
          <p:nvPr/>
        </p:nvSpPr>
        <p:spPr>
          <a:xfrm>
            <a:off x="3852000" y="504000"/>
            <a:ext cx="112164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4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A83BC656-D23C-4031-8331-5023BEB100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0132689"/>
              </p:ext>
            </p:extLst>
          </p:nvPr>
        </p:nvGraphicFramePr>
        <p:xfrm>
          <a:off x="540000" y="720000"/>
          <a:ext cx="342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C40DC701-4E02-4BF9-BB01-332306B58B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9589938"/>
              </p:ext>
            </p:extLst>
          </p:nvPr>
        </p:nvGraphicFramePr>
        <p:xfrm>
          <a:off x="4500000" y="720000"/>
          <a:ext cx="342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875521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デフォルト">
      <a:majorFont>
        <a:latin typeface="ＭＳ Ｐゴシック"/>
        <a:ea typeface="ＭＳ Ｐゴシック"/>
        <a:cs typeface=""/>
      </a:majorFont>
      <a:minorFont>
        <a:latin typeface="ＭＳ Ｐゴシック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22392F13-109E-404A-8250-CFD6FEB70F48}" vid="{23E64650-F422-4C82-B116-6A4615ED5018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89</TotalTime>
  <Words>45</Words>
  <Application>Microsoft Office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游ゴシック</vt:lpstr>
      <vt:lpstr>Arial</vt:lpstr>
      <vt:lpstr>Times New Roman</vt:lpstr>
      <vt:lpstr>Office テーマ</vt:lpstr>
      <vt:lpstr>PowerPoint プレゼンテーション</vt:lpstr>
    </vt:vector>
  </TitlesOfParts>
  <Company>興和株式会社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作成者</dc:creator>
  <cp:lastModifiedBy>作成者</cp:lastModifiedBy>
  <cp:revision>21</cp:revision>
  <dcterms:created xsi:type="dcterms:W3CDTF">2022-01-17T08:48:20Z</dcterms:created>
  <dcterms:modified xsi:type="dcterms:W3CDTF">2023-03-06T07:16:28Z</dcterms:modified>
</cp:coreProperties>
</file>